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310" r:id="rId24"/>
    <p:sldId id="312" r:id="rId25"/>
    <p:sldId id="311" r:id="rId26"/>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6" y="2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C7F3C50-B3A0-4362-6C8B-5CB42C79C2B9}"/>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AF84D3D9-90A9-8FCB-CA35-E9B993A01DC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DEF892EF-8F33-4E14-111C-270149A0AED2}"/>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CFBFCC97-480D-EF68-60B6-D084CC6517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D8B989A7-302D-AB4F-B808-01924C31D1D5}"/>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26306054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7DBE7F9-FB52-D554-9BF6-3C837EC9E933}"/>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63250061-4B79-C626-15D5-198B98DEFDA0}"/>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22602E22-2E09-3EEA-DB53-B269809837D8}"/>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F511A7F5-A83B-CEE4-7BA0-F205AB23AF4B}"/>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6290FDFD-A3A9-95D1-44B3-3807B2A150EC}"/>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37189892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82256691-77D4-148E-67F3-D616525E9A24}"/>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540DC86A-E5EC-583C-723F-464DEE92FE73}"/>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5975F2B1-2371-FD79-C431-04079E4F0BEA}"/>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7CD06A32-F0BC-8E19-F2F2-13D9B6662858}"/>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ACADFA62-1766-7507-0EDB-A5B3A1BB29ED}"/>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6929942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3C207A0-8D58-95B1-C63B-1E14075D7338}"/>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087766B3-3E9E-9DB7-AE7D-063266F9B737}"/>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B021253-E5BC-747C-1CF8-62F61F191E1F}"/>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BFC717B0-95C3-9479-8E7E-BCF6B048D9D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F872B495-906D-48BB-09CF-E2140A64534F}"/>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25697315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94568FF-5D5C-D0B4-F2E7-A636750CF70E}"/>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7BA21ABC-7537-1A6C-C6A4-E8098D1ECA3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771F81B9-2EDC-B275-4758-A8B7EA8B6A3A}"/>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A4A2BC3D-3C1E-B201-AE67-E97BFBB12BF3}"/>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7D850F9C-24CE-778F-43F6-1CD16930DFCD}"/>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14780505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BF260A7-7527-0188-2488-A7504917FC72}"/>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80EADA78-F33E-5CB3-8F81-F0A3E0D8CE71}"/>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876572E9-E0C1-A779-D092-0094B1978E8F}"/>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E2B4E2C9-8731-6E10-9053-6E9D1D07BF56}"/>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6" name="Tijdelijke aanduiding voor voettekst 5">
            <a:extLst>
              <a:ext uri="{FF2B5EF4-FFF2-40B4-BE49-F238E27FC236}">
                <a16:creationId xmlns:a16="http://schemas.microsoft.com/office/drawing/2014/main" id="{74ABDAAB-C52B-8795-A614-549C218B2866}"/>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99088ED6-B554-F17B-82E0-5B8CB6563BB0}"/>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2580335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3D85E8C-D2FC-535D-5818-99C0B8BA8480}"/>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E3B1EC7D-0FEC-58A0-5CCE-FE4D5F5FD1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4DF613CD-247C-5D53-16F9-7F01F1F5105B}"/>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8186D4A5-71B8-9578-D0B4-C7255C064E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5FAD5C0B-FA88-9761-76BD-15B68CFD07E3}"/>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AC929CE9-6D4A-1DE9-31A4-6E121E295D6A}"/>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8" name="Tijdelijke aanduiding voor voettekst 7">
            <a:extLst>
              <a:ext uri="{FF2B5EF4-FFF2-40B4-BE49-F238E27FC236}">
                <a16:creationId xmlns:a16="http://schemas.microsoft.com/office/drawing/2014/main" id="{57719DA7-AF5F-6790-5A0E-DD4E469E48A8}"/>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EB6ECDB4-1E95-E48B-DC12-9D473381B047}"/>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2607344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9922-FC25-2C3E-DAF6-AC2C95EA2F4A}"/>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01539C3-2A4F-0905-9546-C1773480E7D0}"/>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4" name="Tijdelijke aanduiding voor voettekst 3">
            <a:extLst>
              <a:ext uri="{FF2B5EF4-FFF2-40B4-BE49-F238E27FC236}">
                <a16:creationId xmlns:a16="http://schemas.microsoft.com/office/drawing/2014/main" id="{D18C5022-9936-B59A-27F7-C0BDE31C324D}"/>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D1D15611-528C-5C91-3EFD-63208695E501}"/>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24168296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CC8C3CE8-201D-B313-4E73-F274DE014D42}"/>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3" name="Tijdelijke aanduiding voor voettekst 2">
            <a:extLst>
              <a:ext uri="{FF2B5EF4-FFF2-40B4-BE49-F238E27FC236}">
                <a16:creationId xmlns:a16="http://schemas.microsoft.com/office/drawing/2014/main" id="{D2A737A9-0F0B-6B69-29D1-BE68073DA55F}"/>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5151419-9ECD-AFB0-AEC8-BF25C4A3375B}"/>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33465355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024E2CA-69C4-D029-5A1A-A6C90720654F}"/>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7421FCF3-C1C9-093B-9E4E-DCA9EC0A15C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C76EDD8E-D904-D285-4815-0230CEF2A2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70D08306-E3CC-91FA-51AB-4A3449B29FF5}"/>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6" name="Tijdelijke aanduiding voor voettekst 5">
            <a:extLst>
              <a:ext uri="{FF2B5EF4-FFF2-40B4-BE49-F238E27FC236}">
                <a16:creationId xmlns:a16="http://schemas.microsoft.com/office/drawing/2014/main" id="{8E8F326E-3533-BF79-B9A7-D9D6C0AE4FD8}"/>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05C2A62-5E3B-53B3-8228-48C5F6BEE250}"/>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39875781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012A2C0-D12C-9C8C-3FB9-A8C5F766E38B}"/>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1F95970D-73C6-6520-FF21-28798C1F5AC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3A081000-F321-F837-1BD4-36679FFD119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CF381273-1DF5-0AF5-800C-509CDFE1DB04}"/>
              </a:ext>
            </a:extLst>
          </p:cNvPr>
          <p:cNvSpPr>
            <a:spLocks noGrp="1"/>
          </p:cNvSpPr>
          <p:nvPr>
            <p:ph type="dt" sz="half" idx="10"/>
          </p:nvPr>
        </p:nvSpPr>
        <p:spPr/>
        <p:txBody>
          <a:bodyPr/>
          <a:lstStyle/>
          <a:p>
            <a:fld id="{686E3BCB-3ACF-4ACB-A5D4-BC8F6794AA74}" type="datetimeFigureOut">
              <a:rPr lang="nl-NL" smtClean="0"/>
              <a:t>11-07-2022</a:t>
            </a:fld>
            <a:endParaRPr lang="nl-NL"/>
          </a:p>
        </p:txBody>
      </p:sp>
      <p:sp>
        <p:nvSpPr>
          <p:cNvPr id="6" name="Tijdelijke aanduiding voor voettekst 5">
            <a:extLst>
              <a:ext uri="{FF2B5EF4-FFF2-40B4-BE49-F238E27FC236}">
                <a16:creationId xmlns:a16="http://schemas.microsoft.com/office/drawing/2014/main" id="{A0B28332-50B4-CE0E-2B08-BE70CA2314CE}"/>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6AB7167-946F-3EED-A348-E67D1963F490}"/>
              </a:ext>
            </a:extLst>
          </p:cNvPr>
          <p:cNvSpPr>
            <a:spLocks noGrp="1"/>
          </p:cNvSpPr>
          <p:nvPr>
            <p:ph type="sldNum" sz="quarter" idx="12"/>
          </p:nvPr>
        </p:nvSpPr>
        <p:spPr/>
        <p:txBody>
          <a:bodyPr/>
          <a:lstStyle/>
          <a:p>
            <a:fld id="{D36D953B-D0E1-442D-AE7F-27D3B75B3E2F}" type="slidenum">
              <a:rPr lang="nl-NL" smtClean="0"/>
              <a:t>‹#›</a:t>
            </a:fld>
            <a:endParaRPr lang="nl-NL"/>
          </a:p>
        </p:txBody>
      </p:sp>
    </p:spTree>
    <p:extLst>
      <p:ext uri="{BB962C8B-B14F-4D97-AF65-F5344CB8AC3E}">
        <p14:creationId xmlns:p14="http://schemas.microsoft.com/office/powerpoint/2010/main" val="35394387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B2D491BB-D235-F2DD-DDFC-CA5E50D91A1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38390FDE-AE22-6C76-870D-926307C3B87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E91933A0-CEEA-2705-C71A-9B288F80CF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86E3BCB-3ACF-4ACB-A5D4-BC8F6794AA74}" type="datetimeFigureOut">
              <a:rPr lang="nl-NL" smtClean="0"/>
              <a:t>11-07-2022</a:t>
            </a:fld>
            <a:endParaRPr lang="nl-NL"/>
          </a:p>
        </p:txBody>
      </p:sp>
      <p:sp>
        <p:nvSpPr>
          <p:cNvPr id="5" name="Tijdelijke aanduiding voor voettekst 4">
            <a:extLst>
              <a:ext uri="{FF2B5EF4-FFF2-40B4-BE49-F238E27FC236}">
                <a16:creationId xmlns:a16="http://schemas.microsoft.com/office/drawing/2014/main" id="{0E46E615-624E-11DD-F1F6-0BEECCDDDE0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FC9D397D-3A39-B6F5-C706-17C12D001BC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6D953B-D0E1-442D-AE7F-27D3B75B3E2F}" type="slidenum">
              <a:rPr lang="nl-NL" smtClean="0"/>
              <a:t>‹#›</a:t>
            </a:fld>
            <a:endParaRPr lang="nl-NL"/>
          </a:p>
        </p:txBody>
      </p:sp>
    </p:spTree>
    <p:extLst>
      <p:ext uri="{BB962C8B-B14F-4D97-AF65-F5344CB8AC3E}">
        <p14:creationId xmlns:p14="http://schemas.microsoft.com/office/powerpoint/2010/main" val="11501392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6303777"/>
          </a:xfrm>
          <a:prstGeom prst="rect">
            <a:avLst/>
          </a:prstGeom>
          <a:noFill/>
        </p:spPr>
        <p:txBody>
          <a:bodyPr wrap="square" rtlCol="0">
            <a:spAutoFit/>
          </a:bodyPr>
          <a:lstStyle/>
          <a:p>
            <a:pPr algn="ctr">
              <a:lnSpc>
                <a:spcPct val="107000"/>
              </a:lnSpc>
              <a:spcAft>
                <a:spcPts val="800"/>
              </a:spcAft>
            </a:pPr>
            <a:r>
              <a:rPr lang="fr-FR" sz="1800" dirty="0">
                <a:effectLst/>
                <a:latin typeface="Calibri" panose="020F0502020204030204" pitchFamily="34" charset="0"/>
                <a:ea typeface="Calibri" panose="020F0502020204030204" pitchFamily="34" charset="0"/>
                <a:cs typeface="Arial" panose="020B0604020202020204" pitchFamily="34"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প্রতিস্থাপন</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অটোইমিউনিটি</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এবং</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সংক্রমণ</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নিয়ন্ত্রণে</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HLA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অনুর</a:t>
            </a:r>
            <a:r>
              <a:rPr lang="nl-NL" sz="3600" kern="1400" spc="-50" dirty="0">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ভূমিকা</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একটি</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কমিক</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বুক</a:t>
            </a:r>
            <a:r>
              <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kern="1400" spc="-50" dirty="0" err="1">
                <a:solidFill>
                  <a:srgbClr val="FF0000"/>
                </a:solidFill>
                <a:effectLst/>
                <a:latin typeface="Nirmala UI" panose="020B0502040204020203" pitchFamily="34" charset="0"/>
                <a:ea typeface="Times New Roman" panose="02020603050405020304" pitchFamily="18" charset="0"/>
                <a:cs typeface="Times New Roman" panose="02020603050405020304" pitchFamily="18" charset="0"/>
              </a:rPr>
              <a:t>অ্যাডভেঞ্চার</a:t>
            </a: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nSpc>
                <a:spcPct val="107000"/>
              </a:lnSpc>
              <a:spcAft>
                <a:spcPts val="800"/>
              </a:spcAft>
            </a:pP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t>
            </a:r>
            <a:r>
              <a:rPr lang="nl-NL" sz="2400" dirty="0" err="1">
                <a:solidFill>
                  <a:srgbClr val="FF0000"/>
                </a:solidFill>
              </a:rPr>
              <a:t>and</a:t>
            </a:r>
            <a:r>
              <a:rPr lang="nl-NL" sz="2400" dirty="0">
                <a:solidFill>
                  <a:srgbClr val="FF0000"/>
                </a:solidFill>
              </a:rPr>
              <a:t>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3200" dirty="0">
              <a:solidFill>
                <a:srgbClr val="FF0000"/>
              </a:solidFill>
            </a:endParaRPr>
          </a:p>
          <a:p>
            <a:pPr algn="ctr"/>
            <a:endParaRPr lang="nl-NL" sz="3200" dirty="0">
              <a:solidFill>
                <a:srgbClr val="FF0000"/>
              </a:solidFill>
            </a:endParaRPr>
          </a:p>
          <a:p>
            <a:pPr algn="ct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by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R.Mukhopadhyay</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Original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E114F12-2A1C-4AB1-81A1-C0EBFADEB168}"/>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৯</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9)</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B4BC0B9B-C1A2-B7AF-35A5-DDA373B50126}"/>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ডারউই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বুদ্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বশ্য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খুঁ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ঙ্গী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ন্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ও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স্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খুঁজে</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ও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লিমারফিজমে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ধা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বর্ত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7132406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A16AB1B-03F7-B413-5BDE-9B607F975B2D}"/>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০</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0)</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C8CA6F36-F492-C79F-1B48-D0033BEDDB11}"/>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ফ্যাক্ট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ইক্রোবায়া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যাথোজে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তি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চু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নফ্লুয়েঞ্জা</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লপক্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র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জস্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বা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মা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বহা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মন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ব-সীমি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ক্রম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মিউ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স্টে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ছাড়া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ণঘা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শ্ন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হজ</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মিউ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স্টে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লুকি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গুলি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নাক্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মা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ম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6079176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EE37FF2-5A3E-B054-0C46-4911BC5587EF}"/>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১</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1)</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095A086E-DCB3-19A7-683C-F686D6BEA25D}"/>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মিউ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স্টে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ধি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স্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দ্ভাব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যাক্রোফেজ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কটেরি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উট্রোফিল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কটেরি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যা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পাদান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সৃ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ন্টিবডি</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হেল্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হায্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কি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সংক্রমি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গুলি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মন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যান্সা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গুলি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5022009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C30D0E4-1B41-0CCF-689F-E5E67A9333FC}"/>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২</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2)</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1F0B526C-9AA7-5AA1-6A9A-4D138117CC8D}"/>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ন্তু টি-কিলার সেল কিভাবে জানবে কাকে হত্যা করতে হবে</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ল</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রক্ষি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ত্যি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কৃতপক্ষে</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ভাইরাসের প্রতিলিপি হওয়ার সাথে সাথে</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এর প্রোটিনের ক্ষুদ্র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টু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ইচএলএ-এ</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বি বা -সি অণুতে সরবরাহ করা হয় যা তাদের কোষের পৃষ্ঠে নিয়ে যায়। টি-কিলার সেল একটি নির্দিষ্ট এইচএলএ অণুর প্রসঙ্গে এই ছোট খণ্ডটিকে স্বীকৃতি দেয়। এই ঘটনাটি আবিষ্কার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যাকে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সীমাবদ্ধতা বলা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দুটি নোবেল পুরস্কার অর্জনের জন্য যথেষ্ট গুরুত্বপূর্ণ ছিল। প্রতিটি ভিন্ন ধরনের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অণু পেপটাইডের একটি আলাদা ভাণ্ডার উপস্থাপন করে যাতে ইমিউন সিস্টেমকে অনেক টার্গেট দেওয়া হয় যা এইগুলি তৈরি করে এবং কোষগুলিকে মেরে ফেলতে পা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38749754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9375987-632A-2F3A-2CDE-0F3C3C3F809D}"/>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৩</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3)</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63506158-876F-4396-1E21-6524AA55DCDF}"/>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ন্তু কিভাবে একটি ভাইরাস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টুকরো</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প্রথম স্থানে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উৎপন্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ল প্রোটিন -কোষের অভ্যন্তরে অন্যান্য প্রোটিনের মতোই - অবনমিত হয়। প্রোটিনগুলি প্রোটিসোম নামক একটি অসাধারণ ন্যানো-মেশিন দ্বারা খণ্ডিত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মূলত প্রোটিনের জন্য একটি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ডিস্পোজাল</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অন্যান্য কোষের এনজাইম টুকরোর প্রান্তগুলিকে ছোট পেপটাইডগুলিতে ছাঁটাই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র মধ্যে কিছু সাইটোসল থেকে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ER-</a:t>
            </a:r>
            <a:r>
              <a:rPr lang="nl-NL"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স্থানান্তরিত হয় যেখানে তারা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গুলিকে আবদ্ধ করতে পারে। একবার একটি এইচএলএ অণুর একটি আবদ্ধ পেপটাইড হয়ে গেলে</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টি কোষের পৃষ্ঠের জন্য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ER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ছেড়ে যায় যেখানে এটি টি-কিলার কোষ দ্বারা সনাক্তকরণের জন্য অপেক্ষা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16206619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191AB91-8575-EE0A-5A99-81886CF1C971}"/>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৪</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4)</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41AC8EFD-E235-D111-CD14-531A471760F0}"/>
              </a:ext>
            </a:extLst>
          </p:cNvPr>
          <p:cNvSpPr>
            <a:spLocks noGrp="1"/>
          </p:cNvSpPr>
          <p:nvPr>
            <p:ph idx="1"/>
          </p:nvPr>
        </p:nvSpPr>
        <p:spPr/>
        <p:txBody>
          <a:bodyPr>
            <a:normAutofit lnSpcReduction="10000"/>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আসুন এইচএলএ পলিমারফিজমের দিকে ফিরে যাই। পাশাপাশি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COVID-</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19 এবং ইনফ্লুয়েঞ্জা থেকে সবাই জা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সগুলি অ্যান্টিবডি প্রতিক্রিয়া থেকে বাঁচতে পরিবর্তন করতে খুব ভাল (ভাবুন আলফা</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ডেল্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ওমিক্রন...)। টি কোষের জন্য এই সম্ভাবনা কমানোর জন্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তিটি বিভিন্ন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যালিল (জিনের বিভিন্ন প্রকার) পেপটাইডের একটি ভিন্ন সেট উপস্থাপন করে। এত পেপটাইড এক ব্যক্তির মধ্যে উপস্থাপিত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ভাইরাস এড়ানো কঠিন। মানুষের মধ্যে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কারের পার্থক্যের মানে হল যে এটি ঘটলেও</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ড়িয়ে যাওয়া ভাইরাস পরবর্তী ব্যক্তির মধ্যে তার প্রতারণা বজায় রাখবে না। যদি আমরা সবাই এইচএলএ অভিন্ন হতাম</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কটি পালিয়ে যাওয়া ভাইরাস সমগ্র জনসংখ্যাকে মেরে ফেলবে</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খন এটি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শুধুমা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ইচএলএ অণু সহ কিছু ব্যক্তিকে হত্যা করবে যা ইমিউন সিস্টেমে ভাইরাল পেপটাইড উপস্থাপন করতে অক্ষম। এইচএলএ পলিমারফিজম এইভাবে জনসংখ্যাকে রক্ষা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যক্তি কম গুরুত্বপূর্ণ। এটি এমএইচসি পলিমারফিজমের বিবর্তনের জন্য একটি আকর্ষক ব্যাখ্যা প্রদান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5234389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8215811-5D95-6C4D-5EBA-075BCC16D65A}"/>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৫</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5)</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801B8C35-D3CF-8ED1-1DCB-B8F97B53342A}"/>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ন্তু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আপনার জন্য খারাপ খব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য় পাঠক আপনার যদি একটি বা দুটি নতুন অঙ্গের প্রয়োজন হয়। এইচএলএ পলিমারফিজম কিডনি রোগে আক্রান্ত ব্যক্তি ন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কটি প্রজাতির জনসংখ্যার বেঁচে থাকার প্রচার করে। ট্রান্সপ্লান্টেশন প্রত্যাখ্যান হল ইমিউন সিস্টেমের ফলাফল যা একটি দাতা অঙ্গকে ভাইরাস দ্বারা সংক্রামিত অঙ্গের সাথে বিভ্রান্ত করে এবং অঙ্গটিকে আক্রমণ করে সেই অনুযায়ী প্রতিক্রিয়া জানায় যার ফলে প্রতিস্থাপন প্রত্যাখ্যান হয়।</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74974266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12E4E1E-9E52-AF83-B69D-766667C3CA4A}"/>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৬</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6)</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A9F922E0-B053-12F9-C811-F3AD441E835E}"/>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একটি গুরুত্বপূর্ণ সাধারণ পাঠ: ইমিউন সিস্টেম সহ কিছুই নিখুঁত নয়! যার কথা বলতে গি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আসুন চিন্তা করি কীভাবে টি-কিলার কোষগুলি ভাইরাস সংক্রামিত কোষগুলিকে খুব দ্রুত খুঁজে পেতে পারে। ভাইরাস খুব দ্রুত তাদের সন্তান উৎপাদন করতে পা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ছু ক্ষেত্রে মাত্র কয়েক ঘন্টার মধ্যে।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ল</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টিনগুলি</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বাভাবি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জীবনে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শেষে</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ধ্বংস</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হবা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পেক্ষা</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খুব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দীর্ঘ</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কিন্তু ইমিউন সিস্টেমের মতো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ল প্রোটিন সহ প্রোটিনের সংশ্লেষণ নিখুঁত থেকে অনেক দূরে। এই অসম্পূর্ণ প্রোটি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কে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DRiPs</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লা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বিলম্বে ক্ষয়প্রাপ্ত হ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ইরাস সংক্রমণের শুরুকে অ্যান্টিজেন উপস্থাপনের সাথে যুক্ত করে এবং কার্যকর টি-কিলার সেল ইমিউনো নজরদারির অনুমতি দেয়।</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77058129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BDF6253-CB8A-A938-8230-CA81BCB77983}"/>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৭</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7)</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1E065C70-EAA7-27F6-49F3-1B7F1A6FEA9A}"/>
              </a:ext>
            </a:extLst>
          </p:cNvPr>
          <p:cNvSpPr>
            <a:spLocks noGrp="1"/>
          </p:cNvSpPr>
          <p:nvPr>
            <p:ph idx="1"/>
          </p:nvPr>
        </p:nvSpPr>
        <p:spPr/>
        <p:txBody>
          <a:bodyPr/>
          <a:lstStyle/>
          <a:p>
            <a:pPr marL="0" indent="0">
              <a:buNone/>
            </a:pP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স্তিমাত</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ইমিউন সিস্টেম</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ত দ্রুত না! কিছু চতুর ভাইরাস</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শেষ করে হারপিসভাইরাস</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যান্টিজেন উপস্থাপনে হস্তক্ষেপ করার জন্য বিবর্তিত হয়েছে। হিউম্যান সাইটোমেগালোভাইরা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CMV,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৬</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0% মানবতাকে সংক্রামিত করে প্রোটিনের একটি স্যুট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US</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2</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US</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3</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US</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6</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US</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11</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বং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US</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18) তৈরি করে যা পেপটাইড উৎপাদন</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সীমিত</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রে</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বা</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nl-NL"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HLA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লাস</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১</a:t>
            </a:r>
            <a:r>
              <a:rPr lang="nl-NL"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ফাংশনে</a:t>
            </a:r>
            <a:r>
              <a:rPr lang="bn-IN" sz="24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হস্তক্ষেপ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72338832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B02085A-FDE6-E2E8-DDBA-FB2C302219A8}"/>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৮</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8)</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b="1"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F1B574A8-F21D-FF31-6D8F-2D0377371B31}"/>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হ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চএলএ</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লি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ল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ইরা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ক্রম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কাবেলা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তপ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চএল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লি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চআইভি</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র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দে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ভিডে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গজীবা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কা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লি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র্বাচ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দাহরণস্বরূপ</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2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উরোপী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সংখ্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8</a:t>
            </a:r>
            <a:r>
              <a:rPr lang="bn-IN" sz="2400" dirty="0">
                <a:effectLst/>
                <a:latin typeface="Nirmala UI" panose="020B0502040204020203" pitchFamily="34" charset="0"/>
                <a:ea typeface="Calibri" panose="020F0502020204030204" pitchFamily="34" charset="0"/>
                <a:cs typeface="Times New Roman" panose="02020603050405020304" pitchFamily="18" charset="0"/>
              </a:rPr>
              <a:t>0</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ও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র্দিষ্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ষ্ঠী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লি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বাধি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প</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ভব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2-এর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ম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ফ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গজীবা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নুষে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গে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ধা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8550170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3E9318E-00F5-A643-1EA4-605EF23EA546}"/>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૧</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a:t>
            </a:r>
            <a:br>
              <a:rPr lang="nl-NL" sz="36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p>
        </p:txBody>
      </p:sp>
      <p:sp>
        <p:nvSpPr>
          <p:cNvPr id="4" name="Rectangle 1">
            <a:extLst>
              <a:ext uri="{FF2B5EF4-FFF2-40B4-BE49-F238E27FC236}">
                <a16:creationId xmlns:a16="http://schemas.microsoft.com/office/drawing/2014/main" id="{238E77ED-CF9C-FC57-6FEB-671800911A9C}"/>
              </a:ext>
            </a:extLst>
          </p:cNvPr>
          <p:cNvSpPr>
            <a:spLocks noGrp="1" noChangeArrowheads="1"/>
          </p:cNvSpPr>
          <p:nvPr>
            <p:ph idx="1"/>
          </p:nvPr>
        </p:nvSpPr>
        <p:spPr bwMode="auto">
          <a:xfrm>
            <a:off x="804644" y="2664819"/>
            <a:ext cx="11271191" cy="1800493"/>
          </a:xfrm>
          <a:prstGeom prst="rect">
            <a:avLst/>
          </a:prstGeom>
          <a:solidFill>
            <a:srgbClr val="F8F9FA"/>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প্রায়</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૧৯00-বছর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আগে</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দুই</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আরব</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ভাই</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এবং</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ডাক্তার</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কসমাস</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এবং</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ড্যামিয়ানাস</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প্রথম</a:t>
            </a:r>
            <a:r>
              <a:rPr kumimoji="0" lang="nl-NL"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 </a:t>
            </a:r>
            <a:r>
              <a:rPr kumimoji="0" lang="bn-IN" altLang="nl-NL" sz="2400" b="0" i="0" u="none" strike="noStrike" cap="none" normalizeH="0" baseline="0" dirty="0">
                <a:ln>
                  <a:noFill/>
                </a:ln>
                <a:solidFill>
                  <a:srgbClr val="000000"/>
                </a:solidFill>
                <a:effectLst/>
                <a:latin typeface="Nirmala UI" panose="020B0502040204020203" pitchFamily="34" charset="0"/>
                <a:ea typeface="Calibri" panose="020F0502020204030204" pitchFamily="34" charset="0"/>
                <a:cs typeface="Nirmala UI" panose="020B0502040204020203" pitchFamily="34" charset="0"/>
              </a:rPr>
              <a:t>সফল</a:t>
            </a:r>
            <a:r>
              <a:rPr kumimoji="0" lang="nl-NL" altLang="nl-NL" sz="2400" b="0" i="0" u="none" strike="noStrike" cap="none" normalizeH="0" baseline="0" dirty="0">
                <a:ln>
                  <a:noFill/>
                </a:ln>
                <a:solidFill>
                  <a:schemeClr val="tx1"/>
                </a:solidFill>
                <a:effectLst/>
              </a:rPr>
              <a:t> </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প্রতিস্থাপ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করেছিলে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একজ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বণিকের</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গ্যাংগ্রিনাস</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পা</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তার</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ক্রীতদাসের</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সাথে</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প্রতিস্থাপ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করেছিলে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ক্রীতদাসের</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ভাগ্য</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ইতিহাসে</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অজা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তবে</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এটি</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একটি</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স্বেচ্ছায়</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দান</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অসম্ভাব্য</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 </a:t>
            </a:r>
            <a:r>
              <a:rPr kumimoji="0" lang="nl-NL" altLang="nl-NL" sz="2400" b="0" i="0" u="none" strike="noStrike" cap="none" normalizeH="0" baseline="0" dirty="0" err="1">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ছিল</a:t>
            </a:r>
            <a:r>
              <a:rPr kumimoji="0" lang="nl-NL" altLang="nl-NL" sz="2400" b="0" i="0" u="none" strike="noStrike" cap="none" normalizeH="0" baseline="0" dirty="0">
                <a:ln>
                  <a:noFill/>
                </a:ln>
                <a:solidFill>
                  <a:schemeClr val="tx1"/>
                </a:solidFill>
                <a:effectLst/>
                <a:latin typeface="Nirmala UI" panose="020B0502040204020203" pitchFamily="34" charset="0"/>
                <a:ea typeface="Calibri" panose="020F0502020204030204" pitchFamily="34" charset="0"/>
                <a:cs typeface="Nirmala UI" panose="020B0502040204020203" pitchFamily="34" charset="0"/>
              </a:rPr>
              <a:t>।</a:t>
            </a:r>
            <a:endParaRPr kumimoji="0" lang="nl-NL" altLang="nl-NL" sz="2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nl-NL" altLang="nl-NL"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8427450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AE3A8FD-0AD2-91BD-465D-DA45B9937BE1}"/>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১৯</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19)</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8083DB4E-1FA8-BDAD-075B-B913E466BA3E}"/>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ন্তু সমান্তরাল পরিণতি আছে</a:t>
            </a:r>
            <a:r>
              <a:rPr lang="en-US" sz="2400" dirty="0">
                <a:solidFill>
                  <a:srgbClr val="000000"/>
                </a:solidFill>
                <a:latin typeface="Calibri" panose="020F0502020204030204" pitchFamily="34" charset="0"/>
                <a:ea typeface="Calibri" panose="020F0502020204030204" pitchFamily="34" charset="0"/>
                <a:cs typeface="Nirmala UI" panose="020B0502040204020203" pitchFamily="34" charset="0"/>
              </a:rPr>
              <a:t>I</a:t>
            </a: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 </a:t>
            </a:r>
            <a:r>
              <a:rPr lang="bn-IN" sz="2400" dirty="0">
                <a:solidFill>
                  <a:srgbClr val="000000"/>
                </a:solidFill>
                <a:latin typeface="Nirmala UI" panose="020B0502040204020203" pitchFamily="34" charset="0"/>
              </a:rPr>
              <a:t>অ্যালিল</a:t>
            </a:r>
            <a:r>
              <a:rPr lang="en-US" sz="2400" dirty="0">
                <a:solidFill>
                  <a:srgbClr val="000000"/>
                </a:solidFill>
                <a:latin typeface="Nirmala UI" panose="020B0502040204020203" pitchFamily="34" charset="0"/>
                <a:cs typeface="Times New Roman" panose="02020603050405020304" pitchFamily="18" charset="0"/>
              </a:rPr>
              <a:t> </a:t>
            </a:r>
            <a:r>
              <a:rPr lang="bn-IN" altLang="nl-NL" sz="2400" dirty="0">
                <a:solidFill>
                  <a:srgbClr val="000000"/>
                </a:solidFill>
                <a:latin typeface="Nirmala UI" panose="020B0502040204020203" pitchFamily="34" charset="0"/>
              </a:rPr>
              <a:t>এইচএলএ-বি</a:t>
            </a:r>
            <a:r>
              <a:rPr lang="en-US" altLang="nl-NL" sz="2400" dirty="0">
                <a:solidFill>
                  <a:srgbClr val="000000"/>
                </a:solidFill>
                <a:latin typeface="Nirmala UI" panose="020B0502040204020203" pitchFamily="34" charset="0"/>
              </a:rPr>
              <a:t>*</a:t>
            </a:r>
            <a:r>
              <a:rPr lang="as-IN" sz="2400" dirty="0">
                <a:solidFill>
                  <a:srgbClr val="000000"/>
                </a:solidFill>
                <a:latin typeface="Nirmala UI" panose="020B0502040204020203" pitchFamily="34" charset="0"/>
              </a:rPr>
              <a:t>২৭</a:t>
            </a:r>
            <a:r>
              <a:rPr lang="en-US" sz="2400" dirty="0">
                <a:solidFill>
                  <a:srgbClr val="000000"/>
                </a:solidFill>
                <a:latin typeface="Nirmala UI" panose="020B0502040204020203" pitchFamily="34" charset="0"/>
                <a:cs typeface="Times New Roman" panose="02020603050405020304" pitchFamily="18" charset="0"/>
              </a:rPr>
              <a:t>:0</a:t>
            </a:r>
            <a:r>
              <a:rPr lang="as-IN" sz="2400" dirty="0">
                <a:solidFill>
                  <a:srgbClr val="000000"/>
                </a:solidFill>
                <a:latin typeface="Nirmala UI" panose="020B0502040204020203" pitchFamily="34" charset="0"/>
              </a:rPr>
              <a:t>৫</a:t>
            </a:r>
            <a:r>
              <a:rPr lang="en-US" sz="2400" dirty="0">
                <a:solidFill>
                  <a:srgbClr val="000000"/>
                </a:solidFill>
                <a:latin typeface="Nirmala UI" panose="020B0502040204020203" pitchFamily="34"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নিন। ককেশীয় জনসংখ্যার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৮</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এর মধ্যে উপস্থি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৯</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0% এর বেশি অ্যাঙ্কাইলোজিং স্পন্ডিলাইটিস রোগীদের এই অ্যালিল থা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সম্ভবত মেরুদণ্ডে একটি অটোইমিউন টি সেল প্রতিক্রিয়া শুরু করে। ইমিউন সিস্টেম বন্ধুত্বপূর্ণ আগুন থেকে টিস্যুগুলির ক্ষতি না করে কার্যকর অনাক্রম্যতা প্রদানের মধ্যে একটি ছুরির ধারে কাজ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
        <p:nvSpPr>
          <p:cNvPr id="5" name="Rectangle 2">
            <a:extLst>
              <a:ext uri="{FF2B5EF4-FFF2-40B4-BE49-F238E27FC236}">
                <a16:creationId xmlns:a16="http://schemas.microsoft.com/office/drawing/2014/main" id="{C1C85396-D395-4AF8-AC72-232B5F51EBA6}"/>
              </a:ext>
            </a:extLst>
          </p:cNvPr>
          <p:cNvSpPr>
            <a:spLocks noChangeArrowheads="1"/>
          </p:cNvSpPr>
          <p:nvPr/>
        </p:nvSpPr>
        <p:spPr bwMode="auto">
          <a:xfrm>
            <a:off x="0" y="102920"/>
            <a:ext cx="65" cy="251359"/>
          </a:xfrm>
          <a:prstGeom prst="rect">
            <a:avLst/>
          </a:prstGeom>
          <a:solidFill>
            <a:srgbClr val="F8F9FA"/>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0" tIns="-12696" rIns="0" bIns="-12696"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nl-NL" sz="1800" b="0" i="0" u="none" strike="noStrike" cap="none" normalizeH="0" baseline="0" dirty="0">
              <a:ln>
                <a:noFill/>
              </a:ln>
              <a:solidFill>
                <a:schemeClr val="tx1"/>
              </a:solidFill>
              <a:effectLst/>
              <a:latin typeface="Arial" panose="020B0604020202020204" pitchFamily="34" charset="0"/>
            </a:endParaRPr>
          </a:p>
        </p:txBody>
      </p:sp>
      <p:graphicFrame>
        <p:nvGraphicFramePr>
          <p:cNvPr id="7" name="Table 6">
            <a:extLst>
              <a:ext uri="{FF2B5EF4-FFF2-40B4-BE49-F238E27FC236}">
                <a16:creationId xmlns:a16="http://schemas.microsoft.com/office/drawing/2014/main" id="{981507E0-F793-4472-A606-7A8E8B207D01}"/>
              </a:ext>
            </a:extLst>
          </p:cNvPr>
          <p:cNvGraphicFramePr>
            <a:graphicFrameLocks noGrp="1"/>
          </p:cNvGraphicFramePr>
          <p:nvPr>
            <p:extLst>
              <p:ext uri="{D42A27DB-BD31-4B8C-83A1-F6EECF244321}">
                <p14:modId xmlns:p14="http://schemas.microsoft.com/office/powerpoint/2010/main" val="3374122333"/>
              </p:ext>
            </p:extLst>
          </p:nvPr>
        </p:nvGraphicFramePr>
        <p:xfrm>
          <a:off x="3238500" y="3681254"/>
          <a:ext cx="5715000" cy="640080"/>
        </p:xfrm>
        <a:graphic>
          <a:graphicData uri="http://schemas.openxmlformats.org/drawingml/2006/table">
            <a:tbl>
              <a:tblPr/>
              <a:tblGrid>
                <a:gridCol w="5715000">
                  <a:extLst>
                    <a:ext uri="{9D8B030D-6E8A-4147-A177-3AD203B41FA5}">
                      <a16:colId xmlns:a16="http://schemas.microsoft.com/office/drawing/2014/main" val="1005398295"/>
                    </a:ext>
                  </a:extLst>
                </a:gridCol>
              </a:tblGrid>
              <a:tr h="0">
                <a:tc>
                  <a:txBody>
                    <a:bodyPr/>
                    <a:lstStyle/>
                    <a:p>
                      <a:pPr algn="l"/>
                      <a:br>
                        <a:rPr lang="as-IN" dirty="0">
                          <a:effectLst/>
                        </a:rPr>
                      </a:br>
                      <a:endParaRPr lang="as-IN" dirty="0">
                        <a:effectLst/>
                      </a:endParaRPr>
                    </a:p>
                  </a:txBody>
                  <a:tcPr marL="19050" marR="19050" anchor="ctr">
                    <a:lnL>
                      <a:noFill/>
                    </a:lnL>
                    <a:lnR>
                      <a:noFill/>
                    </a:lnR>
                    <a:lnT>
                      <a:noFill/>
                    </a:lnT>
                    <a:lnB>
                      <a:noFill/>
                    </a:lnB>
                    <a:solidFill>
                      <a:srgbClr val="FFFFFF"/>
                    </a:solidFill>
                  </a:tcPr>
                </a:tc>
                <a:extLst>
                  <a:ext uri="{0D108BD9-81ED-4DB2-BD59-A6C34878D82A}">
                    <a16:rowId xmlns:a16="http://schemas.microsoft.com/office/drawing/2014/main" val="716643492"/>
                  </a:ext>
                </a:extLst>
              </a:tr>
            </a:tbl>
          </a:graphicData>
        </a:graphic>
      </p:graphicFrame>
      <p:graphicFrame>
        <p:nvGraphicFramePr>
          <p:cNvPr id="8" name="Table 7">
            <a:extLst>
              <a:ext uri="{FF2B5EF4-FFF2-40B4-BE49-F238E27FC236}">
                <a16:creationId xmlns:a16="http://schemas.microsoft.com/office/drawing/2014/main" id="{D36EC053-88C8-497B-AABD-81B48A1AA6F9}"/>
              </a:ext>
            </a:extLst>
          </p:cNvPr>
          <p:cNvGraphicFramePr>
            <a:graphicFrameLocks noGrp="1"/>
          </p:cNvGraphicFramePr>
          <p:nvPr>
            <p:extLst>
              <p:ext uri="{D42A27DB-BD31-4B8C-83A1-F6EECF244321}">
                <p14:modId xmlns:p14="http://schemas.microsoft.com/office/powerpoint/2010/main" val="4179751569"/>
              </p:ext>
            </p:extLst>
          </p:nvPr>
        </p:nvGraphicFramePr>
        <p:xfrm>
          <a:off x="2073397" y="3681254"/>
          <a:ext cx="8045206" cy="640080"/>
        </p:xfrm>
        <a:graphic>
          <a:graphicData uri="http://schemas.openxmlformats.org/drawingml/2006/table">
            <a:tbl>
              <a:tblPr/>
              <a:tblGrid>
                <a:gridCol w="8045206">
                  <a:extLst>
                    <a:ext uri="{9D8B030D-6E8A-4147-A177-3AD203B41FA5}">
                      <a16:colId xmlns:a16="http://schemas.microsoft.com/office/drawing/2014/main" val="1755703478"/>
                    </a:ext>
                  </a:extLst>
                </a:gridCol>
              </a:tblGrid>
              <a:tr h="0">
                <a:tc>
                  <a:txBody>
                    <a:bodyPr/>
                    <a:lstStyle/>
                    <a:p>
                      <a:br>
                        <a:rPr lang="as-IN" dirty="0">
                          <a:effectLst/>
                        </a:rPr>
                      </a:br>
                      <a:endParaRPr lang="as-IN" dirty="0">
                        <a:effectLst/>
                      </a:endParaRPr>
                    </a:p>
                  </a:txBody>
                  <a:tcPr anchor="ctr">
                    <a:lnL>
                      <a:noFill/>
                    </a:lnL>
                    <a:lnR>
                      <a:noFill/>
                    </a:lnR>
                    <a:lnT>
                      <a:noFill/>
                    </a:lnT>
                    <a:lnB>
                      <a:noFill/>
                    </a:lnB>
                    <a:solidFill>
                      <a:srgbClr val="FFFFFF"/>
                    </a:solidFill>
                  </a:tcPr>
                </a:tc>
                <a:extLst>
                  <a:ext uri="{0D108BD9-81ED-4DB2-BD59-A6C34878D82A}">
                    <a16:rowId xmlns:a16="http://schemas.microsoft.com/office/drawing/2014/main" val="3633728286"/>
                  </a:ext>
                </a:extLst>
              </a:tr>
            </a:tbl>
          </a:graphicData>
        </a:graphic>
      </p:graphicFrame>
    </p:spTree>
    <p:extLst>
      <p:ext uri="{BB962C8B-B14F-4D97-AF65-F5344CB8AC3E}">
        <p14:creationId xmlns:p14="http://schemas.microsoft.com/office/powerpoint/2010/main" val="25882167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E5F0B4B-C3CE-5A81-6FAF-7BBC238674D6}"/>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২০</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20)</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11E94901-ACA9-F4B0-A1D9-40174DB6553D}"/>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টি সেল অটোইমিউনিটিও উপকারী হতে পারে। ক্যান্সার কোষে সাধারণত অনেক মিউটেশন এবং অন্যান্য পরিবর্তন থাকে।</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পেপটাইড তৈরি করে, যা সাধারণ সেলুলার পেপটাইড থেকে আলাদা। ক্যান্সার ইমিউনোথেরাপি ক্যান্সার কোষকে হত্যা করার জন্য ভাইরাল এবং ব্যাকটেরিয়া সংক্রমণ সনাক্ত করতে ইমিউন সিস্টেম দ্বারা ব্যবহৃত প্রক্রিয়াগুলিকে কাজে লাগায়।</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9020270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C85ACBA-50B8-696D-4312-3EBF858625BD}"/>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২১</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21)</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4EEA0897-DA38-F317-B4A1-3BE597D0C201}"/>
              </a:ext>
            </a:extLst>
          </p:cNvPr>
          <p:cNvSpPr>
            <a:spLocks noGrp="1"/>
          </p:cNvSpPr>
          <p:nvPr>
            <p:ph idx="1"/>
          </p:nvPr>
        </p:nvSpPr>
        <p:spPr/>
        <p:txBody>
          <a:bodyPr/>
          <a:lstStyle/>
          <a:p>
            <a:pPr marL="0" indent="0" algn="just">
              <a:lnSpc>
                <a:spcPct val="100000"/>
              </a:lnSpc>
              <a:spcAft>
                <a:spcPts val="800"/>
              </a:spcAft>
              <a:buNone/>
              <a:tabLst>
                <a:tab pos="58166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কিন্তু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DR, -DQ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বং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DP 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সম্পর্কে 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ই অণুগুলি টি-হেল্পার কোষগুলিতে প্যাথোজেনিক পেপটাইডগুলি উপস্থাপন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পরে বি কোষগুলিকে অ্যান্টিবডি তৈরির কারখানায় পার্থক্য করতে সাহায্য করার জন্য সাইটোকাইন তৈরি করে। টি-হেল্পার সেলগুলি টি-কিলার প্রতিক্রিয়াগুলিকে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ঠি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তেও সাহায্য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just">
              <a:lnSpc>
                <a:spcPct val="100000"/>
              </a:lnSpc>
              <a:spcAft>
                <a:spcPts val="800"/>
              </a:spcAft>
              <a:buNone/>
              <a:tabLst>
                <a:tab pos="581660" algn="l"/>
                <a:tab pos="1163320" algn="l"/>
                <a:tab pos="1744980" algn="l"/>
                <a:tab pos="2326640" algn="l"/>
                <a:tab pos="2908300" algn="l"/>
                <a:tab pos="3489960" algn="l"/>
                <a:tab pos="4071620" algn="l"/>
                <a:tab pos="4653280" algn="l"/>
                <a:tab pos="5234940" algn="l"/>
                <a:tab pos="5816600" algn="l"/>
                <a:tab pos="6398260" algn="l"/>
                <a:tab pos="6979920" algn="l"/>
                <a:tab pos="7561580" algn="l"/>
                <a:tab pos="8143240" algn="l"/>
                <a:tab pos="8724900" algn="l"/>
                <a:tab pos="9306560" algn="l"/>
              </a:tabLst>
            </a:pP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 আকারের সাথে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 অত্যন্ত মিল রয়েছে কিন্তু বর্তমান প্রোটিন টুকরা যা লম্বা এবং লাইসোসোমে 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ছোট অর্গানেল যা কোষের বাইরে থেকে অর্জিত প্রোটিনগুলিকে হ্রাস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75624007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62F3E93-F463-8232-BE08-0C68D41693A5}"/>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২২</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22)</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92A6EB1A-7874-43DF-0C90-93C38A4B351C}"/>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তারা এটা কিভাবে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ER-</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 তৈরি করা হয় (কোষের বাইরের ঝিল্লি বা লাইসোসোমে যেতে হয় এমন অন্য প্রোটিনের মতো) যেখানে এটি একটি প্রোটিন (অপরিবর্তনশীল শৃঙ্খল) আবদ্ধ করে যা একটি পেপটাইডের অনুকরণ করে এবং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চাপেরণে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দ্বা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লাইসোসোমে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দি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সারি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এখা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পরিবর্তনীয় চেইন অপসারণ করা হয় এবং লাইসোসোমাল এনজাইম দ্বারা তৈরি একটি পেপটাইডের জন্য বিনিময় করা হয়। এই প্রক্রিয়াটি অন্য ধরনের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DM,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 দেখতে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 ম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বং কিছু কোষে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HLA-DO-</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 সাথে মিলিতভাবে কাজ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আরেকটি 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 মতো অণু দ্বারা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ঠি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 হয়।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বর্তনে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দ্ধ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ধী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যখ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য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শাখা</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খ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টি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শুধুমা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নুলিপি এবং সংশোধন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জ</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চালা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নতু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আরেক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শাখা</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লস</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এই জটিল নৃত্যের নেট ফলাফল হল পেপটাইড সহ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কোষের পৃষ্ঠে সরবরাহ করা যা টি-হেল্পার সেল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ক্রিয়করণে</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সক্ষম করে।</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
        <p:nvSpPr>
          <p:cNvPr id="4" name="Rectangle 1">
            <a:extLst>
              <a:ext uri="{FF2B5EF4-FFF2-40B4-BE49-F238E27FC236}">
                <a16:creationId xmlns:a16="http://schemas.microsoft.com/office/drawing/2014/main" id="{8E190C5E-BA22-4536-AD9F-78A6BC0F4C59}"/>
              </a:ext>
            </a:extLst>
          </p:cNvPr>
          <p:cNvSpPr>
            <a:spLocks noChangeArrowheads="1"/>
          </p:cNvSpPr>
          <p:nvPr/>
        </p:nvSpPr>
        <p:spPr bwMode="auto">
          <a:xfrm>
            <a:off x="0" y="0"/>
            <a:ext cx="12192000" cy="457200"/>
          </a:xfrm>
          <a:prstGeom prst="rect">
            <a:avLst/>
          </a:prstGeom>
          <a:solidFill>
            <a:srgbClr val="F8F9FA"/>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0" tIns="-12696" rIns="0" bIns="-12696"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bn-IN" altLang="nl-NL" sz="1800" b="0" i="0" u="none" strike="noStrike" cap="none" normalizeH="0" baseline="0">
                <a:ln>
                  <a:noFill/>
                </a:ln>
                <a:solidFill>
                  <a:srgbClr val="202124"/>
                </a:solidFill>
                <a:effectLst/>
                <a:latin typeface="inherit"/>
                <a:cs typeface="Vrinda" panose="020B0502040204020203" pitchFamily="34" charset="0"/>
              </a:rPr>
              <a:t>এনজাইম</a:t>
            </a:r>
            <a:r>
              <a:rPr kumimoji="0" lang="bn-IN" altLang="nl-NL" sz="800" b="0" i="0" u="none" strike="noStrike" cap="none" normalizeH="0" baseline="0">
                <a:ln>
                  <a:noFill/>
                </a:ln>
                <a:solidFill>
                  <a:schemeClr val="tx1"/>
                </a:solidFill>
                <a:effectLst/>
                <a:cs typeface="Vrinda" panose="020B0502040204020203" pitchFamily="34" charset="0"/>
              </a:rPr>
              <a:t> </a:t>
            </a:r>
            <a:endParaRPr kumimoji="0" lang="en-US" altLang="nl-NL"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32383033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F0EB7F0-9DE1-4624-7F85-4F4C94C39337}"/>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২৪</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24)</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429DE103-3AC4-342F-D99F-FEABF2520016}"/>
              </a:ext>
            </a:extLst>
          </p:cNvPr>
          <p:cNvSpPr>
            <a:spLocks noGrp="1"/>
          </p:cNvSpPr>
          <p:nvPr>
            <p:ph idx="1"/>
          </p:nvPr>
        </p:nvSpPr>
        <p:spPr/>
        <p:txBody>
          <a:bodyPr/>
          <a:lstStyle/>
          <a:p>
            <a:pPr marL="0" indent="0">
              <a:buNone/>
            </a:pP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গুলি টিকাদানে গুরুত্বপূর্ণ অংশগ্রহণকারী। সমস্ত ভ্যাকসিন এমএইচসি 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ব্যবহার করে অ্যান্টিবডি প্রতিক্রিয়ার জন্য। প্রয়োজনীয় টি-হেল্পার কোষগুলিকে প্ররোচিত করে এবং প্রোটিন তৈরি করে যার বিরুদ্ধে অ্যান্টিবডি প্রতিক্রিয়া নির্দেশিত হয়। অ্যাডেনোভাইরাস এবং এমআরএনএ ভ্যাকসিনগুলিও টি-কিলার কোষগুলিকে প্ররোচিত করতে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লা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I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ব্যবহার করে। ভ্যাকসিন দ্বারা প্ররোচিত টি কোষগুলি মূল ভাইরাসের সাথে একটি নতুন সংক্রমণের জন্য সতর্কতার জন্য অনেক বছ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মনকি কিছু ক্ষেত্রে কয়েক দশক ধরে চলে। ভ্যাকসিনগুলি অন্যান্য সমস্ত চিকিৎসা হস্তক্ষেপের চেয়ে অনেক বেশি জীবন বাঁচিয়েছে। এই বার্তা ছড়িয়ে দি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রোগ ন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টিকা নিন!</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400951216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BA44ACC-A769-A4AB-6E5A-2533A26BEFD9}"/>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পরিশেষ</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err="1">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Epilogue</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A9E29B24-E0EC-C890-6730-A53ACD8A4AC3}"/>
              </a:ext>
            </a:extLst>
          </p:cNvPr>
          <p:cNvSpPr>
            <a:spLocks noGrp="1"/>
          </p:cNvSpPr>
          <p:nvPr>
            <p:ph idx="1"/>
          </p:nvPr>
        </p:nvSpPr>
        <p:spPr/>
        <p:txBody>
          <a:bodyPr/>
          <a:lstStyle/>
          <a:p>
            <a:pPr marL="0" indent="0">
              <a:buNone/>
            </a:pPr>
            <a:r>
              <a:rPr lang="bn-IN" sz="2400" dirty="0">
                <a:solidFill>
                  <a:srgbClr val="000000"/>
                </a:solidFill>
                <a:effectLst/>
                <a:latin typeface="Calibri" panose="020F0502020204030204" pitchFamily="34" charset="0"/>
                <a:ea typeface="Calibri" panose="020F0502020204030204" pitchFamily="34" charset="0"/>
                <a:cs typeface="Nirmala UI" panose="020B0502040204020203" pitchFamily="34" charset="0"/>
              </a:rPr>
              <a:t>তাই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MHC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ণু সংক্রমণ নিয়ন্ত্রণ ক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রোগ প্রতিরোধ ক্ষমতা নিয়ন্ত্রণ করে এবং এখন ক্যান্সার নিরাময়ে সাহায্য করছে। এটি অটো-ইমিউনিটি এবং ট্রান্সপ্লান্ট প্রত্যাখ্যানের নেতিবাচক দিকগুলির জন্য ভাল।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সে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ণে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আপ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জীবাণু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ভরা</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থিবী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স</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রছে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কমিক</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বই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জীবি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বস্থায়</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ড়তে</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পারছেন</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কীভাবে আরও ভালভাবে বেঁচে থাকা যায় সে সম্পর্কে আরও বিশদ বিবরণের জন্য</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অনুগ্রহ করে রেফারেন্স </a:t>
            </a:r>
            <a:r>
              <a:rPr lang="nl-NL"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১-৬</a:t>
            </a:r>
            <a:r>
              <a:rPr lang="bn-IN" sz="2400" dirty="0">
                <a:solidFill>
                  <a:srgbClr val="000000"/>
                </a:solidFill>
                <a:effectLst/>
                <a:latin typeface="Nirmala UI" panose="020B0502040204020203" pitchFamily="34" charset="0"/>
                <a:ea typeface="Calibri" panose="020F0502020204030204" pitchFamily="34" charset="0"/>
                <a:cs typeface="Times New Roman" panose="02020603050405020304" pitchFamily="18" charset="0"/>
              </a:rPr>
              <a:t> দেখুন।</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0454929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27F38B-F1ED-6188-C76D-0CF66B6B8041}"/>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২</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2)</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148C5AF8-3A2B-A3A7-BFD8-B72CC5BE2EB1}"/>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লৌকি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ফুল্লতা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বদা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খে</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ফ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ষ্ঠপোষ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ওঠে</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খ্রিস্টা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শ্বাসে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রশ্ছেদ</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ভব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বর্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রোহণে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শোধ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1879212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5D1A694-328D-0D9C-4823-B8AEF59FC140}"/>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৩</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3)</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01172852-409C-8A57-39EA-B2E8FC45F999}"/>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ঠি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বর্ত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মন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ডারউইন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শ্চয়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বা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ন</a:t>
            </a:r>
            <a:r>
              <a:rPr lang="en-US" sz="2400" dirty="0">
                <a:effectLst/>
                <a:latin typeface="Nirmala UI" panose="020B0502040204020203" pitchFamily="34" charset="0"/>
                <a:ea typeface="Calibri" panose="020F0502020204030204" pitchFamily="34" charset="0"/>
                <a:cs typeface="Nirmala UI" panose="020B0502040204020203" pitchFamily="34" charset="0"/>
              </a:rPr>
              <a:t>…</a:t>
            </a:r>
            <a:r>
              <a:rPr lang="en-US"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রেণী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পর্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তে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শ</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8690917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C60FCB-F376-A2C1-EA9A-5B01B26A44E5}"/>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৪</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4)</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7F97E548-AD15-BF07-D196-EBD7E0B2DF19}"/>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মা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রীরে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দু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রেণী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জ</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ঝা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থে</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শু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বোচ্চ্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লিমরফি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ক্তিত্বে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থক্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স্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যা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নুষে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লিমরফি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রান্সপ্লান্টেশ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যান্টিজে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ধারণ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MH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MH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নুষে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3845012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30E2BCD-C891-29FD-E115-A4DBF13A1A59}"/>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৫</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5)</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501785A7-1556-2462-A87B-413C52B44B3B}"/>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বচে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রুত্বপূ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ণুগুলি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MH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 HLA-B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MH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লাস</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II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DR, HLA-DQ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DP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 -B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য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মা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স্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লা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ক্তকণি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তী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পস্থি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খ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DR, HLA-DQ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DP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ধা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রোধ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3465868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C34BD7F-DD6B-BB0B-B806-69ACDFC7E114}"/>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৬</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6)</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0B9592D9-662E-474A-887D-419C44A360AE}"/>
              </a:ext>
            </a:extLst>
          </p:cNvPr>
          <p:cNvSpPr>
            <a:spLocks noGrp="1"/>
          </p:cNvSpPr>
          <p:nvPr>
            <p:ph idx="1"/>
          </p:nvPr>
        </p:nvSpPr>
        <p:spPr/>
        <p:txBody>
          <a:bodyPr/>
          <a:lstStyle/>
          <a:p>
            <a:pPr marL="0" indent="0">
              <a:buNone/>
            </a:pPr>
            <a:r>
              <a:rPr lang="nl-NL" sz="2400" dirty="0">
                <a:effectLst/>
                <a:latin typeface="Nirmala UI" panose="020B0502040204020203" pitchFamily="34" charset="0"/>
                <a:ea typeface="Calibri" panose="020F0502020204030204" pitchFamily="34" charset="0"/>
                <a:cs typeface="Times New Roman" panose="02020603050405020304" pitchFamily="18" charset="0"/>
              </a:rPr>
              <a:t>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ণু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তটা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হুরূপী</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র্ভব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হি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য়শ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ন্টিবডি</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টি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ক্ষা</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পলব্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ও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র্ধারণ</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বহা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র্ভব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হিলা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স্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বহা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মশালা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হিলাদে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গু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ল্যা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মশালা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দেও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রা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ক্রিয়াগু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নিম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ভাবেই</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B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C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চিহ্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গু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ভিন্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রূপ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গুলি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হজ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1,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র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2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ত্যাদি</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ম্ব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দেও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ছি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৷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DR, -DQ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DP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ণু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থে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ঘটেছে</a:t>
            </a:r>
            <a:r>
              <a:rPr lang="nl-NL" sz="2400" dirty="0">
                <a:effectLst/>
                <a:latin typeface="Nirmala UI" panose="020B0502040204020203" pitchFamily="34" charset="0"/>
                <a:ea typeface="Calibri" panose="020F0502020204030204" pitchFamily="34" charset="0"/>
                <a:cs typeface="Times New Roman" panose="02020603050405020304" pitchFamily="18" charset="0"/>
              </a:rPr>
              <a:t>৷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টিস্যু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উদাহরণস্বরূপ</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1, -B8, -Cw7, -DR3, -DQ2,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DPw1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A2, -B27, -Cw1, -DR4, -DQ3,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বা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DPw4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টি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থাক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8026210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B7FDB1A-76E3-2DB7-FBEB-D05E796284F8}"/>
              </a:ext>
            </a:extLst>
          </p:cNvPr>
          <p:cNvSpPr>
            <a:spLocks noGrp="1"/>
          </p:cNvSpPr>
          <p:nvPr>
            <p:ph type="title"/>
          </p:nvPr>
        </p:nvSpPr>
        <p:spPr/>
        <p:txBody>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৭</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7)</a:t>
            </a:r>
            <a:br>
              <a:rPr lang="nl-NL" sz="1800" b="1" dirty="0">
                <a:solidFill>
                  <a:srgbClr val="2F5496"/>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dirty="0"/>
          </a:p>
        </p:txBody>
      </p:sp>
      <p:sp>
        <p:nvSpPr>
          <p:cNvPr id="3" name="Tijdelijke aanduiding voor inhoud 2">
            <a:extLst>
              <a:ext uri="{FF2B5EF4-FFF2-40B4-BE49-F238E27FC236}">
                <a16:creationId xmlns:a16="http://schemas.microsoft.com/office/drawing/2014/main" id="{8046BA66-CA2C-43CD-F338-CDDF8955A99A}"/>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জকা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effectLst/>
                <a:latin typeface="Calibri" panose="020F0502020204030204" pitchFamily="34" charset="0"/>
                <a:ea typeface="Calibri" panose="020F0502020204030204" pitchFamily="34" charset="0"/>
                <a:cs typeface="Nirmala UI" panose="020B0502040204020203" pitchFamily="34" charset="0"/>
              </a:rPr>
              <a:t>HLA টাইপিং নিয়মিতভাবে ডিএনএ বিশ্লেষণের মাধ্যমে করা হয়। কিছু প্রমাণ রয়েছে যে মহিলারা গন্ধের মাধ্যমে পুরুষদের HLA-</a:t>
            </a:r>
            <a:r>
              <a:rPr lang="bn-IN" sz="2400" dirty="0">
                <a:effectLst/>
                <a:latin typeface="Calibri" panose="020F0502020204030204"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র</a:t>
            </a:r>
            <a:r>
              <a:rPr lang="bn-IN" sz="2400" dirty="0">
                <a:effectLst/>
                <a:latin typeface="Nirmala UI" panose="020B0502040204020203" pitchFamily="34" charset="0"/>
                <a:ea typeface="Calibri" panose="020F0502020204030204" pitchFamily="34" charset="0"/>
                <a:cs typeface="Times New Roman" panose="02020603050405020304" pitchFamily="18" charset="0"/>
              </a:rPr>
              <a:t> ধরণের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ধ্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bn-IN" sz="2400" dirty="0">
                <a:effectLst/>
                <a:latin typeface="Nirmala UI" panose="020B0502040204020203" pitchFamily="34" charset="0"/>
                <a:ea typeface="Calibri" panose="020F0502020204030204" pitchFamily="34" charset="0"/>
                <a:cs typeface="Times New Roman" panose="02020603050405020304" pitchFamily="18" charset="0"/>
              </a:rPr>
              <a:t>পার্থক্য সনাক্ত করতে পারে এবং এটি জিনগতভাবে ভিন্ন সঙ্গীর জন্য নির্বাচন করতে অবদান রাখে।</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13441430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C44858B-E2D6-82B2-3AD9-0F55D49EE088}"/>
              </a:ext>
            </a:extLst>
          </p:cNvPr>
          <p:cNvSpPr>
            <a:spLocks noGrp="1"/>
          </p:cNvSpPr>
          <p:nvPr>
            <p:ph type="title"/>
          </p:nvPr>
        </p:nvSpPr>
        <p:spPr/>
        <p:txBody>
          <a:bodyPr>
            <a:normAutofit/>
          </a:bodyPr>
          <a:lstStyle/>
          <a:p>
            <a:r>
              <a:rPr lang="nl-NL" sz="3600" b="1" dirty="0" err="1">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স্লাইড</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a:t>
            </a:r>
            <a:r>
              <a:rPr lang="nl-NL" sz="3600" b="1" dirty="0">
                <a:solidFill>
                  <a:schemeClr val="accent5">
                    <a:lumMod val="75000"/>
                  </a:schemeClr>
                </a:solidFill>
                <a:effectLst/>
                <a:latin typeface="Nirmala UI" panose="020B0502040204020203" pitchFamily="34" charset="0"/>
                <a:ea typeface="Times New Roman" panose="02020603050405020304" pitchFamily="18" charset="0"/>
                <a:cs typeface="Times New Roman" panose="02020603050405020304" pitchFamily="18" charset="0"/>
              </a:rPr>
              <a:t>৮</a:t>
            </a:r>
            <a: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t>: (Slide 8)</a:t>
            </a:r>
            <a:br>
              <a:rPr lang="nl-NL" sz="3600" b="1" dirty="0">
                <a:solidFill>
                  <a:schemeClr val="accent5">
                    <a:lumMod val="75000"/>
                  </a:schemeClr>
                </a:solidFill>
                <a:effectLst/>
                <a:latin typeface="Calibri Light" panose="020F0302020204030204" pitchFamily="34" charset="0"/>
                <a:ea typeface="Times New Roman" panose="02020603050405020304" pitchFamily="18" charset="0"/>
                <a:cs typeface="Times New Roman" panose="02020603050405020304" pitchFamily="18" charset="0"/>
              </a:rPr>
            </a:br>
            <a:endParaRPr lang="nl-NL" sz="3600" dirty="0">
              <a:solidFill>
                <a:schemeClr val="accent5">
                  <a:lumMod val="75000"/>
                </a:schemeClr>
              </a:solidFill>
            </a:endParaRPr>
          </a:p>
        </p:txBody>
      </p:sp>
      <p:sp>
        <p:nvSpPr>
          <p:cNvPr id="3" name="Tijdelijke aanduiding voor inhoud 2">
            <a:extLst>
              <a:ext uri="{FF2B5EF4-FFF2-40B4-BE49-F238E27FC236}">
                <a16:creationId xmlns:a16="http://schemas.microsoft.com/office/drawing/2014/main" id="{235F1A56-7406-A506-D028-9B5899C1AA9E}"/>
              </a:ext>
            </a:extLst>
          </p:cNvPr>
          <p:cNvSpPr>
            <a:spLocks noGrp="1"/>
          </p:cNvSpPr>
          <p:nvPr>
            <p:ph idx="1"/>
          </p:nvPr>
        </p:nvSpPr>
        <p:spPr/>
        <p:txBody>
          <a:bodyPr/>
          <a:lstStyle/>
          <a:p>
            <a:pPr marL="0" indent="0">
              <a:buNone/>
            </a:pP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দিও</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লিমরফিজম</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নব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চিত্র্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আন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হায্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ফ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ঙ্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স্থাপ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শাল</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জন্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গ্রহী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দাতা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HLA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ধরনে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যত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সম্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ঘনিষ্ঠভাবে</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লা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য়োজ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একটি</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নিখুঁ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মিলে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নুপস্থিতিতে</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অঙ্গ</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যাখ্যান</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প্রতিরো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য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ইম্মুনোসাপ্রেসিভ</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ওষুধ</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ব্যবহা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করা</a:t>
            </a:r>
            <a:r>
              <a:rPr lang="nl-NL" sz="2400" dirty="0">
                <a:effectLst/>
                <a:latin typeface="Nirmala UI" panose="020B0502040204020203" pitchFamily="34" charset="0"/>
                <a:ea typeface="Calibri" panose="020F0502020204030204" pitchFamily="34" charset="0"/>
                <a:cs typeface="Times New Roman" panose="02020603050405020304" pitchFamily="18" charset="0"/>
              </a:rPr>
              <a:t> </a:t>
            </a:r>
            <a:r>
              <a:rPr lang="nl-NL" sz="2400" dirty="0" err="1">
                <a:effectLst/>
                <a:latin typeface="Nirmala UI" panose="020B0502040204020203" pitchFamily="34" charset="0"/>
                <a:ea typeface="Calibri" panose="020F0502020204030204" pitchFamily="34" charset="0"/>
                <a:cs typeface="Times New Roman" panose="02020603050405020304" pitchFamily="18" charset="0"/>
              </a:rPr>
              <a:t>হয়</a:t>
            </a:r>
            <a:r>
              <a:rPr lang="nl-NL" sz="2400" dirty="0">
                <a:effectLst/>
                <a:latin typeface="Nirmala UI" panose="020B0502040204020203" pitchFamily="34" charset="0"/>
                <a:ea typeface="Calibri" panose="020F0502020204030204" pitchFamily="34" charset="0"/>
                <a:cs typeface="Times New Roman" panose="02020603050405020304" pitchFamily="18" charset="0"/>
              </a:rPr>
              <a:t>।</a:t>
            </a:r>
            <a:endParaRPr lang="nl-NL" sz="24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nl-NL" dirty="0"/>
          </a:p>
        </p:txBody>
      </p:sp>
    </p:spTree>
    <p:extLst>
      <p:ext uri="{BB962C8B-B14F-4D97-AF65-F5344CB8AC3E}">
        <p14:creationId xmlns:p14="http://schemas.microsoft.com/office/powerpoint/2010/main" val="2011919058"/>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5</TotalTime>
  <Words>2121</Words>
  <Application>Microsoft Office PowerPoint</Application>
  <PresentationFormat>Widescreen</PresentationFormat>
  <Paragraphs>63</Paragraphs>
  <Slides>25</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5</vt:i4>
      </vt:variant>
    </vt:vector>
  </HeadingPairs>
  <TitlesOfParts>
    <vt:vector size="33" baseType="lpstr">
      <vt:lpstr>Arial</vt:lpstr>
      <vt:lpstr>BlinkMacSystemFont</vt:lpstr>
      <vt:lpstr>Calibri</vt:lpstr>
      <vt:lpstr>Calibri Light</vt:lpstr>
      <vt:lpstr>inherit</vt:lpstr>
      <vt:lpstr>Nirmala UI</vt:lpstr>
      <vt:lpstr>Open Sans</vt:lpstr>
      <vt:lpstr>Kantoorthema</vt:lpstr>
      <vt:lpstr>PowerPoint Presentation</vt:lpstr>
      <vt:lpstr>স্লাইড ૧:  (Slide 1) </vt:lpstr>
      <vt:lpstr>স্লাইড ২: (Slide 2) </vt:lpstr>
      <vt:lpstr>স্লাইড ৩: (Slide 3) </vt:lpstr>
      <vt:lpstr>স্লাইড ৪: (Slide 4) </vt:lpstr>
      <vt:lpstr>স্লাইড ৫: (Slide 5) </vt:lpstr>
      <vt:lpstr>স্লাইড ৬: (Slide 6) </vt:lpstr>
      <vt:lpstr>স্লাইড ৭: (Slide 7) </vt:lpstr>
      <vt:lpstr>স্লাইড ৮: (Slide 8) </vt:lpstr>
      <vt:lpstr>স্লাইড ৯: (Slide 9) </vt:lpstr>
      <vt:lpstr>স্লাইড ১০: (Slide 10) </vt:lpstr>
      <vt:lpstr>স্লাইড ১১: (Slide 11) </vt:lpstr>
      <vt:lpstr>স্লাইড ১২: (Slide 12) </vt:lpstr>
      <vt:lpstr>স্লাইড ১৩: (Slide 13) </vt:lpstr>
      <vt:lpstr>স্লাইড ১৪: (Slide 14) </vt:lpstr>
      <vt:lpstr>স্লাইড ১৫: (Slide 15) </vt:lpstr>
      <vt:lpstr>স্লাইড ১৬: (Slide 16) </vt:lpstr>
      <vt:lpstr>স্লাইড ১৭: (Slide 17) </vt:lpstr>
      <vt:lpstr>স্লাইড ১৮: (Slide 18) </vt:lpstr>
      <vt:lpstr>স্লাইড ১৯: (Slide 19) </vt:lpstr>
      <vt:lpstr>স্লাইড ২০: (Slide 20) </vt:lpstr>
      <vt:lpstr>স্লাইড ২১: (Slide 21) </vt:lpstr>
      <vt:lpstr>স্লাইড ২২: (Slide 22) </vt:lpstr>
      <vt:lpstr>স্লাইড ২৪: (Slide 24) </vt:lpstr>
      <vt:lpstr>পরিশেষ: (Epilogu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9</cp:revision>
  <dcterms:created xsi:type="dcterms:W3CDTF">2022-06-25T10:35:35Z</dcterms:created>
  <dcterms:modified xsi:type="dcterms:W3CDTF">2022-07-11T14:24:04Z</dcterms:modified>
</cp:coreProperties>
</file>